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5" r:id="rId2"/>
    <p:sldId id="266" r:id="rId3"/>
    <p:sldId id="279" r:id="rId4"/>
    <p:sldId id="273" r:id="rId5"/>
    <p:sldId id="274" r:id="rId6"/>
    <p:sldId id="263" r:id="rId7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4B82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6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79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CB5510-3FDF-47AD-8801-9252660697B0}" type="datetimeFigureOut">
              <a:rPr kumimoji="1" lang="ja-JP" altLang="en-US" smtClean="0"/>
              <a:t>2023/2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22743C8-0FCA-47D4-BC0F-344B2CB950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1474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22743C8-0FCA-47D4-BC0F-344B2CB950F2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83615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92B13FA-3B27-D6EA-AB5C-799A20D2C2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8BF10FC-41E9-9ADA-B896-44987A1A9C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D380DA9-A2CA-D732-F385-0E99FDCA06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D48CC-C0EE-4621-8EBC-62F8D74F2AB6}" type="datetimeFigureOut">
              <a:rPr kumimoji="1" lang="ja-JP" altLang="en-US" smtClean="0"/>
              <a:t>2023/2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D089693-A4EF-F981-0DD7-DAFBC3973B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918D5EB-8848-BAE4-5A74-6EA8B75DAB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7E2FD-C548-41C4-81A9-C9A6EDE029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21278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5B664EE-29FB-6CE6-EFA7-82511C2640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86CD4DA-1369-E7A4-851C-38A0250016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00A2323-8462-F07D-3871-C1D6A8BEAE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D48CC-C0EE-4621-8EBC-62F8D74F2AB6}" type="datetimeFigureOut">
              <a:rPr kumimoji="1" lang="ja-JP" altLang="en-US" smtClean="0"/>
              <a:t>2023/2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A1B8D0B-AD79-267C-181A-B8595E5C60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A7B363F-CEC3-0F0C-3DC4-E386F4C0D7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7E2FD-C548-41C4-81A9-C9A6EDE029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97282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F967AE4F-8315-C8BE-43E0-53F0DAB0512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F00DF5E-7897-1A57-A415-E3D3FFD1BF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5308639-FB58-0D26-5886-8AE4221E11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D48CC-C0EE-4621-8EBC-62F8D74F2AB6}" type="datetimeFigureOut">
              <a:rPr kumimoji="1" lang="ja-JP" altLang="en-US" smtClean="0"/>
              <a:t>2023/2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EF11E3B-4DB6-1F98-7C63-08DD051EE3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CCE2CB3-63AB-9B50-16C0-43314D15C3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7E2FD-C548-41C4-81A9-C9A6EDE029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549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61F704E-ABAB-2C02-9546-AE4625F79C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58EA99E-7001-5068-634E-04F72C1703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4F750AC-E2F3-F26B-3D83-871A5D478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D48CC-C0EE-4621-8EBC-62F8D74F2AB6}" type="datetimeFigureOut">
              <a:rPr kumimoji="1" lang="ja-JP" altLang="en-US" smtClean="0"/>
              <a:t>2023/2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5808703-0C77-8F70-B400-CEBA4EF2FC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1123840-D283-B42A-8469-6D1B4F3C74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7E2FD-C548-41C4-81A9-C9A6EDE029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1164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533571A-D492-F3C2-4E5A-A5B773FB17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14CBF1D-3040-EA2A-EFD9-0413CF4CF8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73A3B3E-84AF-CD4E-FC19-5E2AF53CDF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D48CC-C0EE-4621-8EBC-62F8D74F2AB6}" type="datetimeFigureOut">
              <a:rPr kumimoji="1" lang="ja-JP" altLang="en-US" smtClean="0"/>
              <a:t>2023/2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1C737B7-6C73-CF8A-8EFB-FF49A0A553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FBD58FB-CC0B-80A0-C1B0-0F56BB69CB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7E2FD-C548-41C4-81A9-C9A6EDE029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1092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96044A-0960-89D9-9C7E-F67DDC0D3B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C80BDFC-528E-1C4D-C00F-9C78CB6D4B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3880B98-D797-530C-AD64-2834677B8C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5CA5110-1682-3F39-35F2-5FE5996B73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D48CC-C0EE-4621-8EBC-62F8D74F2AB6}" type="datetimeFigureOut">
              <a:rPr kumimoji="1" lang="ja-JP" altLang="en-US" smtClean="0"/>
              <a:t>2023/2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EB94AAD-C66F-1F62-D6A2-B24091428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1144732-5367-2298-0C81-74990CC4CB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7E2FD-C548-41C4-81A9-C9A6EDE029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4473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7824023-7E31-0680-0A2E-10C7E1ECA8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7DD457D-799A-2613-42C0-B15821D561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FD4EFC0-78B0-8E87-BC67-1B8028DF75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53B270E-9DF2-72CE-792C-DC333656A7E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5961C7D-F4CE-4D60-403C-4B46A27BC8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3E6D559-7277-5D49-97F7-F938DCAF89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D48CC-C0EE-4621-8EBC-62F8D74F2AB6}" type="datetimeFigureOut">
              <a:rPr kumimoji="1" lang="ja-JP" altLang="en-US" smtClean="0"/>
              <a:t>2023/2/1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C6CC120-2323-7674-89E4-54F65CCB9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6D3F89E-3621-9026-A126-1EF20EE2D8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7E2FD-C548-41C4-81A9-C9A6EDE029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4970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83D415D-512C-B33E-5672-6196A4D528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033D5B7-C37D-011A-649C-F3DBAFFF78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D48CC-C0EE-4621-8EBC-62F8D74F2AB6}" type="datetimeFigureOut">
              <a:rPr kumimoji="1" lang="ja-JP" altLang="en-US" smtClean="0"/>
              <a:t>2023/2/1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CBDB7A0-2701-145A-25DF-BF9CD1C169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CA32819-4372-40F6-DB7C-EAA33C0FF6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7E2FD-C548-41C4-81A9-C9A6EDE029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7326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8F2BF9C-269C-23DE-17DD-B6DB060354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D48CC-C0EE-4621-8EBC-62F8D74F2AB6}" type="datetimeFigureOut">
              <a:rPr kumimoji="1" lang="ja-JP" altLang="en-US" smtClean="0"/>
              <a:t>2023/2/1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4703A31-08A8-5810-F640-C3A30C0D72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FC22BDB-A5BC-41C4-75FF-B5715A3319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7E2FD-C548-41C4-81A9-C9A6EDE029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6691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731CE9-8378-9E06-C466-FB8CCB499E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0E5B6C6-B134-A35C-A478-EC8552A18F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0F9FFEA-56E4-AA64-577F-4E3E40D828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CDFAD53-30F9-A18F-3AFF-C032DEC26A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D48CC-C0EE-4621-8EBC-62F8D74F2AB6}" type="datetimeFigureOut">
              <a:rPr kumimoji="1" lang="ja-JP" altLang="en-US" smtClean="0"/>
              <a:t>2023/2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58B2047-5066-5811-541C-3D0758E4E5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D0CFF34-57C0-20D2-B20B-DD4CEF5BE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7E2FD-C548-41C4-81A9-C9A6EDE029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1409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CB48D13-2B71-A2E3-E996-A77BA4D374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77070A8-CB9E-FC11-739D-46632418D51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BD839A7-D009-AD61-5FEC-2BBCC61C80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D6C6BDD-17B6-EF78-F4C8-1FAF026647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5D48CC-C0EE-4621-8EBC-62F8D74F2AB6}" type="datetimeFigureOut">
              <a:rPr kumimoji="1" lang="ja-JP" altLang="en-US" smtClean="0"/>
              <a:t>2023/2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FEFE4FD-2B03-F92A-8011-19F739508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C85783C-53D6-AA04-8C35-8BDFBF7994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7E2FD-C548-41C4-81A9-C9A6EDE029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31749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7802D42-3C22-DED3-CFE9-52F0E443F6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6D8A64B-41C8-CF47-456E-186B43BF67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0C30110-2C91-D60C-68E3-29D6F3AD4D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5D48CC-C0EE-4621-8EBC-62F8D74F2AB6}" type="datetimeFigureOut">
              <a:rPr kumimoji="1" lang="ja-JP" altLang="en-US" smtClean="0"/>
              <a:t>2023/2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4215702-DE00-DF56-4A4E-08B060B4CC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0917CB5-8189-23D2-8287-F226822E800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E7E2FD-C548-41C4-81A9-C9A6EDE029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00499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F9C41099-5E8D-D34B-1603-A267D7E6192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8158313"/>
              </p:ext>
            </p:extLst>
          </p:nvPr>
        </p:nvGraphicFramePr>
        <p:xfrm>
          <a:off x="3314278" y="1729865"/>
          <a:ext cx="4899654" cy="301752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260149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29816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14163">
                <a:tc>
                  <a:txBody>
                    <a:bodyPr/>
                    <a:lstStyle/>
                    <a:p>
                      <a:endParaRPr kumimoji="1" lang="ja-JP" altLang="en-US" sz="16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14163">
                <a:tc>
                  <a:txBody>
                    <a:bodyPr/>
                    <a:lstStyle/>
                    <a:p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Gemcitabine + nab-paclitaxel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50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95789487"/>
                  </a:ext>
                </a:extLst>
              </a:tr>
              <a:tr h="314163">
                <a:tc>
                  <a:txBody>
                    <a:bodyPr/>
                    <a:lstStyle/>
                    <a:p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Gemcitabine + S-1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3812386"/>
                  </a:ext>
                </a:extLst>
              </a:tr>
              <a:tr h="314163">
                <a:tc>
                  <a:txBody>
                    <a:bodyPr/>
                    <a:lstStyle/>
                    <a:p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Gemcitabine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5907095"/>
                  </a:ext>
                </a:extLst>
              </a:tr>
              <a:tr h="314163">
                <a:tc>
                  <a:txBody>
                    <a:bodyPr/>
                    <a:lstStyle/>
                    <a:p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FOLFIRINOX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14163">
                <a:tc>
                  <a:txBody>
                    <a:bodyPr/>
                    <a:lstStyle/>
                    <a:p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FOLFIRI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baseline="0" dirty="0">
                          <a:ln w="10160">
                            <a:noFill/>
                            <a:prstDash val="solid"/>
                          </a:ln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5886446"/>
                  </a:ext>
                </a:extLst>
              </a:tr>
              <a:tr h="314163">
                <a:tc>
                  <a:txBody>
                    <a:bodyPr/>
                    <a:lstStyle/>
                    <a:p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FOLFOX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0042621"/>
                  </a:ext>
                </a:extLst>
              </a:tr>
              <a:tr h="314163">
                <a:tc>
                  <a:txBody>
                    <a:bodyPr/>
                    <a:lstStyle/>
                    <a:p>
                      <a:r>
                        <a:rPr kumimoji="1" lang="en-US" altLang="ja-JP" sz="16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S-1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7170">
                <a:tc>
                  <a:txBody>
                    <a:bodyPr/>
                    <a:lstStyle/>
                    <a:p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Radiation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4487515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2EF2855-3CFA-5134-0044-D3F79BAE9BD7}"/>
              </a:ext>
            </a:extLst>
          </p:cNvPr>
          <p:cNvSpPr txBox="1"/>
          <p:nvPr/>
        </p:nvSpPr>
        <p:spPr>
          <a:xfrm>
            <a:off x="144075" y="203378"/>
            <a:ext cx="60972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Table </a:t>
            </a:r>
            <a:r>
              <a:rPr lang="en-US" altLang="ja-JP" b="1" i="1" dirty="0">
                <a:latin typeface="Times New Roman" panose="02020603050405020304" pitchFamily="18" charset="0"/>
                <a:ea typeface="游明朝" panose="02020400000000000000" pitchFamily="18" charset="-128"/>
              </a:rPr>
              <a:t>S</a:t>
            </a:r>
            <a:r>
              <a:rPr lang="en-US" altLang="ja-JP" sz="1800" b="1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1. Chemotherapy before nal-IRI+5-FU/LV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6471194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37FB7397-EAF7-56DA-4113-838AB4C7290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26210300"/>
              </p:ext>
            </p:extLst>
          </p:nvPr>
        </p:nvGraphicFramePr>
        <p:xfrm>
          <a:off x="2566219" y="1311271"/>
          <a:ext cx="6821129" cy="377928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233998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5993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1060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10604">
                  <a:extLst>
                    <a:ext uri="{9D8B030D-6E8A-4147-A177-3AD203B41FA5}">
                      <a16:colId xmlns:a16="http://schemas.microsoft.com/office/drawing/2014/main" val="2100758265"/>
                    </a:ext>
                  </a:extLst>
                </a:gridCol>
              </a:tblGrid>
              <a:tr h="396000">
                <a:tc>
                  <a:txBody>
                    <a:bodyPr/>
                    <a:lstStyle/>
                    <a:p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n=54</a:t>
                      </a:r>
                      <a:endParaRPr kumimoji="1" lang="ja-JP" altLang="en-US" sz="16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6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nal</a:t>
                      </a:r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-IRI</a:t>
                      </a:r>
                      <a:endParaRPr kumimoji="1" lang="ja-JP" altLang="en-US" sz="16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5-FU</a:t>
                      </a:r>
                      <a:endParaRPr kumimoji="1" lang="ja-JP" altLang="en-US" sz="16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Received cycles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Median</a:t>
                      </a:r>
                      <a:r>
                        <a:rPr kumimoji="1" lang="ja-JP" altLang="en-US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(range)</a:t>
                      </a:r>
                    </a:p>
                    <a:p>
                      <a:pPr algn="l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Total</a:t>
                      </a:r>
                      <a:r>
                        <a:rPr kumimoji="1" lang="ja-JP" altLang="en-US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cycles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5 (1-22)</a:t>
                      </a:r>
                    </a:p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437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800" dirty="0">
                        <a:solidFill>
                          <a:schemeClr val="tx1"/>
                        </a:solidFill>
                        <a:latin typeface="メイリオ" panose="020B0604030504040204" pitchFamily="50" charset="-128"/>
                        <a:ea typeface="メイリオ" panose="020B0604030504040204" pitchFamily="50" charset="-128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483812386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Starting</a:t>
                      </a:r>
                      <a:r>
                        <a:rPr kumimoji="1" lang="ja-JP" altLang="en-US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dose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Full</a:t>
                      </a:r>
                    </a:p>
                    <a:p>
                      <a:pPr algn="l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Reduced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34 (63.0%)</a:t>
                      </a:r>
                    </a:p>
                    <a:p>
                      <a:pPr algn="ctr"/>
                      <a:r>
                        <a:rPr kumimoji="1" lang="en-US" altLang="ja-JP" sz="16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20 (37.0%)</a:t>
                      </a:r>
                      <a:endParaRPr kumimoji="1" lang="ja-JP" altLang="en-US" sz="16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kern="0" cap="none" spc="0" baseline="0" dirty="0">
                          <a:ln w="10160">
                            <a:noFill/>
                            <a:prstDash val="solid"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45 (83.3%)</a:t>
                      </a:r>
                    </a:p>
                    <a:p>
                      <a:pPr algn="ctr"/>
                      <a:r>
                        <a:rPr kumimoji="1" lang="en-US" altLang="ja-JP" sz="16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9 (16.7%)</a:t>
                      </a:r>
                      <a:endParaRPr kumimoji="1" lang="ja-JP" altLang="en-US" sz="16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r>
                        <a:rPr kumimoji="1" lang="en-US" altLang="ja-JP" sz="16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Dose</a:t>
                      </a:r>
                      <a:r>
                        <a:rPr kumimoji="1" lang="ja-JP" altLang="en-US" sz="16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6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reduction</a:t>
                      </a:r>
                      <a:r>
                        <a:rPr kumimoji="1" lang="ja-JP" altLang="en-US" sz="1600" b="0" baseline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6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in</a:t>
                      </a:r>
                    </a:p>
                    <a:p>
                      <a:r>
                        <a:rPr kumimoji="1" lang="en-US" altLang="ja-JP" sz="16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subsequent cycles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ja-JP" altLang="en-US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≥</a:t>
                      </a:r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ja-JP" altLang="en-US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times</a:t>
                      </a:r>
                    </a:p>
                    <a:p>
                      <a:pPr algn="l"/>
                      <a:r>
                        <a:rPr kumimoji="1" lang="ja-JP" altLang="en-US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≥</a:t>
                      </a:r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2 times 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20 (37.0%)</a:t>
                      </a:r>
                    </a:p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 (1.9%)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5 (27.8%)</a:t>
                      </a:r>
                    </a:p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49975">
                <a:tc>
                  <a:txBody>
                    <a:bodyPr/>
                    <a:lstStyle/>
                    <a:p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Reason</a:t>
                      </a:r>
                      <a:r>
                        <a:rPr kumimoji="1" lang="ja-JP" altLang="en-US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for</a:t>
                      </a:r>
                      <a:r>
                        <a:rPr kumimoji="1" lang="ja-JP" altLang="en-US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</a:t>
                      </a:r>
                      <a:endParaRPr kumimoji="1" lang="en-US" altLang="ja-JP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  <a:p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dose</a:t>
                      </a:r>
                      <a:r>
                        <a:rPr kumimoji="1" lang="ja-JP" altLang="en-US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reduction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Neutropenia</a:t>
                      </a:r>
                      <a:endParaRPr kumimoji="1" lang="en-US" altLang="ja-JP" sz="1600" b="0" baseline="0" dirty="0">
                        <a:ln w="10160">
                          <a:solidFill>
                            <a:srgbClr val="0000FF"/>
                          </a:solidFill>
                          <a:prstDash val="solid"/>
                        </a:ln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  <a:p>
                      <a:pPr algn="l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Anorexia</a:t>
                      </a:r>
                    </a:p>
                    <a:p>
                      <a:pPr algn="l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Fatigue</a:t>
                      </a:r>
                    </a:p>
                    <a:p>
                      <a:pPr algn="l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Other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2 (22.2%)</a:t>
                      </a:r>
                    </a:p>
                    <a:p>
                      <a:pPr algn="ctr"/>
                      <a:r>
                        <a:rPr kumimoji="1" lang="en-US" altLang="ja-JP" sz="16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7 (13.0%) </a:t>
                      </a:r>
                    </a:p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3 (5.6%)</a:t>
                      </a:r>
                    </a:p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7 (13.0%)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6 (11.1%)</a:t>
                      </a:r>
                    </a:p>
                    <a:p>
                      <a:pPr algn="ctr"/>
                      <a:r>
                        <a:rPr kumimoji="1" lang="en-US" altLang="ja-JP" sz="16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6 (11.1%)</a:t>
                      </a:r>
                    </a:p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 (1.9%)</a:t>
                      </a:r>
                    </a:p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4 (7.4%)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Relative dose intensity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Median</a:t>
                      </a:r>
                    </a:p>
                    <a:p>
                      <a:pPr algn="l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(range)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.74</a:t>
                      </a:r>
                    </a:p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(0.35-0.99)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.81</a:t>
                      </a:r>
                    </a:p>
                    <a:p>
                      <a:pPr algn="ctr"/>
                      <a:r>
                        <a:rPr kumimoji="1" lang="en-US" altLang="ja-JP" sz="16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(0.45-1.00)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4804428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4D04245-7DB8-2956-D2B5-37D8672127AF}"/>
              </a:ext>
            </a:extLst>
          </p:cNvPr>
          <p:cNvSpPr txBox="1"/>
          <p:nvPr/>
        </p:nvSpPr>
        <p:spPr>
          <a:xfrm>
            <a:off x="144075" y="203378"/>
            <a:ext cx="60972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Table S2. Treatment details for all patients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8114637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図 15">
            <a:extLst>
              <a:ext uri="{FF2B5EF4-FFF2-40B4-BE49-F238E27FC236}">
                <a16:creationId xmlns:a16="http://schemas.microsoft.com/office/drawing/2014/main" id="{EE12E004-70FD-E3B8-F666-16D61772373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90684" y="3982727"/>
            <a:ext cx="4093398" cy="514355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A8333A67-C498-D402-E9B5-EA37C074489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63650" y="3974331"/>
            <a:ext cx="4093398" cy="514355"/>
          </a:xfrm>
          <a:prstGeom prst="rect">
            <a:avLst/>
          </a:prstGeom>
        </p:spPr>
      </p:pic>
      <p:pic>
        <p:nvPicPr>
          <p:cNvPr id="45" name="図 44">
            <a:extLst>
              <a:ext uri="{FF2B5EF4-FFF2-40B4-BE49-F238E27FC236}">
                <a16:creationId xmlns:a16="http://schemas.microsoft.com/office/drawing/2014/main" id="{E63ADB6B-CACA-5283-CD2C-FF9900370F7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47834" y="1402822"/>
            <a:ext cx="4036248" cy="2607488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7CF31285-CF3F-BFCE-C671-0A6010BE121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31474" y="1389097"/>
            <a:ext cx="4036248" cy="2607488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943FA783-F5D7-53DF-F3B5-446CDE63AB1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18017" y="1383798"/>
            <a:ext cx="1000133" cy="2664638"/>
          </a:xfrm>
          <a:prstGeom prst="rect">
            <a:avLst/>
          </a:prstGeom>
        </p:spPr>
      </p:pic>
      <p:graphicFrame>
        <p:nvGraphicFramePr>
          <p:cNvPr id="12" name="表 11">
            <a:extLst>
              <a:ext uri="{FF2B5EF4-FFF2-40B4-BE49-F238E27FC236}">
                <a16:creationId xmlns:a16="http://schemas.microsoft.com/office/drawing/2014/main" id="{CF9185CB-606A-B32B-BD85-556CBBFB48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5476659"/>
              </p:ext>
            </p:extLst>
          </p:nvPr>
        </p:nvGraphicFramePr>
        <p:xfrm>
          <a:off x="-452216" y="4744633"/>
          <a:ext cx="1884878" cy="103382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84878">
                  <a:extLst>
                    <a:ext uri="{9D8B030D-6E8A-4147-A177-3AD203B41FA5}">
                      <a16:colId xmlns:a16="http://schemas.microsoft.com/office/drawing/2014/main" val="2535621530"/>
                    </a:ext>
                  </a:extLst>
                </a:gridCol>
              </a:tblGrid>
              <a:tr h="267956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*1/*28</a:t>
                      </a:r>
                    </a:p>
                  </a:txBody>
                  <a:tcPr marL="4763" marR="4763" marT="4763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3707802"/>
                  </a:ext>
                </a:extLst>
              </a:tr>
              <a:tr h="255289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*1/*6</a:t>
                      </a:r>
                    </a:p>
                  </a:txBody>
                  <a:tcPr marL="4763" marR="4763" marT="4763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3927445"/>
                  </a:ext>
                </a:extLst>
              </a:tr>
              <a:tr h="255289">
                <a:tc>
                  <a:txBody>
                    <a:bodyPr/>
                    <a:lstStyle/>
                    <a:p>
                      <a:pPr algn="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2513185"/>
                  </a:ext>
                </a:extLst>
              </a:tr>
              <a:tr h="255289">
                <a:tc>
                  <a:txBody>
                    <a:bodyPr/>
                    <a:lstStyle/>
                    <a:p>
                      <a:pPr algn="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5671373"/>
                  </a:ext>
                </a:extLst>
              </a:tr>
            </a:tbl>
          </a:graphicData>
        </a:graphic>
      </p:graphicFrame>
      <p:graphicFrame>
        <p:nvGraphicFramePr>
          <p:cNvPr id="13" name="表 12">
            <a:extLst>
              <a:ext uri="{FF2B5EF4-FFF2-40B4-BE49-F238E27FC236}">
                <a16:creationId xmlns:a16="http://schemas.microsoft.com/office/drawing/2014/main" id="{5519E056-87E8-C99E-D6B9-D021618B214B}"/>
              </a:ext>
            </a:extLst>
          </p:cNvPr>
          <p:cNvGraphicFramePr>
            <a:graphicFrameLocks noGrp="1"/>
          </p:cNvGraphicFramePr>
          <p:nvPr/>
        </p:nvGraphicFramePr>
        <p:xfrm>
          <a:off x="1597211" y="4474634"/>
          <a:ext cx="1853652" cy="22415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53652">
                  <a:extLst>
                    <a:ext uri="{9D8B030D-6E8A-4147-A177-3AD203B41FA5}">
                      <a16:colId xmlns:a16="http://schemas.microsoft.com/office/drawing/2014/main" val="2535621530"/>
                    </a:ext>
                  </a:extLst>
                </a:gridCol>
              </a:tblGrid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No at risk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3927445"/>
                  </a:ext>
                </a:extLst>
              </a:tr>
            </a:tbl>
          </a:graphicData>
        </a:graphic>
      </p:graphicFrame>
      <p:pic>
        <p:nvPicPr>
          <p:cNvPr id="17" name="図 16">
            <a:extLst>
              <a:ext uri="{FF2B5EF4-FFF2-40B4-BE49-F238E27FC236}">
                <a16:creationId xmlns:a16="http://schemas.microsoft.com/office/drawing/2014/main" id="{7EBA5801-7058-F51F-6F69-92DC7FDC5B1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862003" y="1407043"/>
            <a:ext cx="885831" cy="2664638"/>
          </a:xfrm>
          <a:prstGeom prst="rect">
            <a:avLst/>
          </a:prstGeom>
        </p:spPr>
      </p:pic>
      <p:graphicFrame>
        <p:nvGraphicFramePr>
          <p:cNvPr id="20" name="表 19">
            <a:extLst>
              <a:ext uri="{FF2B5EF4-FFF2-40B4-BE49-F238E27FC236}">
                <a16:creationId xmlns:a16="http://schemas.microsoft.com/office/drawing/2014/main" id="{E993E81A-F9ED-599D-BC59-9719EB36D139}"/>
              </a:ext>
            </a:extLst>
          </p:cNvPr>
          <p:cNvGraphicFramePr>
            <a:graphicFrameLocks noGrp="1"/>
          </p:cNvGraphicFramePr>
          <p:nvPr/>
        </p:nvGraphicFramePr>
        <p:xfrm>
          <a:off x="7582669" y="4465278"/>
          <a:ext cx="1853652" cy="22415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53652">
                  <a:extLst>
                    <a:ext uri="{9D8B030D-6E8A-4147-A177-3AD203B41FA5}">
                      <a16:colId xmlns:a16="http://schemas.microsoft.com/office/drawing/2014/main" val="2535621530"/>
                    </a:ext>
                  </a:extLst>
                </a:gridCol>
              </a:tblGrid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No at risk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3927445"/>
                  </a:ext>
                </a:extLst>
              </a:tr>
            </a:tbl>
          </a:graphicData>
        </a:graphic>
      </p:graphicFrame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5A3D121-BF6D-2B78-EF68-63844EE72F2F}"/>
              </a:ext>
            </a:extLst>
          </p:cNvPr>
          <p:cNvSpPr txBox="1"/>
          <p:nvPr/>
        </p:nvSpPr>
        <p:spPr>
          <a:xfrm>
            <a:off x="3216480" y="1358268"/>
            <a:ext cx="132440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ea typeface="Meiryo" panose="020B0604030504040204" pitchFamily="34" charset="-128"/>
                <a:cs typeface="Calibri" panose="020F0502020204030204" pitchFamily="34" charset="0"/>
              </a:rPr>
              <a:t>*1/*28(n=10)</a:t>
            </a:r>
          </a:p>
          <a:p>
            <a:r>
              <a:rPr lang="en-US" altLang="ja-JP" sz="1600" dirty="0">
                <a:latin typeface="Calibri" panose="020F0502020204030204" pitchFamily="34" charset="0"/>
                <a:ea typeface="Meiryo" panose="020B0604030504040204" pitchFamily="34" charset="-128"/>
                <a:cs typeface="Calibri" panose="020F0502020204030204" pitchFamily="34" charset="0"/>
              </a:rPr>
              <a:t>*1/*6 (n=12) </a:t>
            </a:r>
          </a:p>
        </p:txBody>
      </p: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391ADE34-690B-8FA7-E1C7-254AFD55231E}"/>
              </a:ext>
            </a:extLst>
          </p:cNvPr>
          <p:cNvCxnSpPr>
            <a:cxnSpLocks/>
          </p:cNvCxnSpPr>
          <p:nvPr/>
        </p:nvCxnSpPr>
        <p:spPr>
          <a:xfrm>
            <a:off x="2896959" y="1524247"/>
            <a:ext cx="288000" cy="0"/>
          </a:xfrm>
          <a:prstGeom prst="line">
            <a:avLst/>
          </a:prstGeom>
          <a:ln w="25400">
            <a:solidFill>
              <a:srgbClr val="D0334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587946AD-DA6E-C3EC-B1EF-9D3152EC40E1}"/>
              </a:ext>
            </a:extLst>
          </p:cNvPr>
          <p:cNvCxnSpPr>
            <a:cxnSpLocks/>
          </p:cNvCxnSpPr>
          <p:nvPr/>
        </p:nvCxnSpPr>
        <p:spPr>
          <a:xfrm>
            <a:off x="2896959" y="1772866"/>
            <a:ext cx="288000" cy="0"/>
          </a:xfrm>
          <a:prstGeom prst="line">
            <a:avLst/>
          </a:prstGeom>
          <a:ln w="25400">
            <a:solidFill>
              <a:srgbClr val="0051D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CCBE3675-5D0A-734B-E0F4-E07BA8D7C897}"/>
              </a:ext>
            </a:extLst>
          </p:cNvPr>
          <p:cNvCxnSpPr>
            <a:cxnSpLocks/>
          </p:cNvCxnSpPr>
          <p:nvPr/>
        </p:nvCxnSpPr>
        <p:spPr>
          <a:xfrm>
            <a:off x="9636973" y="1524247"/>
            <a:ext cx="288000" cy="0"/>
          </a:xfrm>
          <a:prstGeom prst="line">
            <a:avLst/>
          </a:prstGeom>
          <a:ln w="25400">
            <a:solidFill>
              <a:srgbClr val="D0334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30E61C42-1BD9-78EA-52E0-4DC107625BEF}"/>
              </a:ext>
            </a:extLst>
          </p:cNvPr>
          <p:cNvCxnSpPr>
            <a:cxnSpLocks/>
          </p:cNvCxnSpPr>
          <p:nvPr/>
        </p:nvCxnSpPr>
        <p:spPr>
          <a:xfrm>
            <a:off x="9636973" y="1772866"/>
            <a:ext cx="288000" cy="0"/>
          </a:xfrm>
          <a:prstGeom prst="line">
            <a:avLst/>
          </a:prstGeom>
          <a:ln w="25400">
            <a:solidFill>
              <a:srgbClr val="0051D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A54F3881-63BC-6E59-6960-EDC63203151B}"/>
              </a:ext>
            </a:extLst>
          </p:cNvPr>
          <p:cNvSpPr txBox="1"/>
          <p:nvPr/>
        </p:nvSpPr>
        <p:spPr>
          <a:xfrm rot="16200000">
            <a:off x="-700858" y="2410262"/>
            <a:ext cx="3172570" cy="5539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500" dirty="0">
                <a:latin typeface="Calibri" panose="020F0502020204030204" pitchFamily="34" charset="0"/>
                <a:cs typeface="Calibri" panose="020F0502020204030204" pitchFamily="34" charset="0"/>
              </a:rPr>
              <a:t>Probability </a:t>
            </a:r>
            <a:r>
              <a:rPr lang="en-US" altLang="ja-JP" sz="1500" dirty="0">
                <a:latin typeface="Calibri" panose="020F0502020204030204" pitchFamily="34" charset="0"/>
                <a:cs typeface="Calibri" panose="020F0502020204030204" pitchFamily="34" charset="0"/>
              </a:rPr>
              <a:t>o</a:t>
            </a:r>
            <a:r>
              <a:rPr kumimoji="1" lang="en-US" altLang="ja-JP" sz="1500" dirty="0">
                <a:latin typeface="Calibri" panose="020F0502020204030204" pitchFamily="34" charset="0"/>
                <a:cs typeface="Calibri" panose="020F0502020204030204" pitchFamily="34" charset="0"/>
              </a:rPr>
              <a:t>f </a:t>
            </a:r>
          </a:p>
          <a:p>
            <a:pPr algn="ctr"/>
            <a:r>
              <a:rPr kumimoji="1" lang="en-US" altLang="ja-JP" sz="1500" dirty="0">
                <a:latin typeface="Calibri" panose="020F0502020204030204" pitchFamily="34" charset="0"/>
                <a:cs typeface="Calibri" panose="020F0502020204030204" pitchFamily="34" charset="0"/>
              </a:rPr>
              <a:t>progression free survival</a:t>
            </a:r>
            <a:endParaRPr kumimoji="1" lang="ja-JP" altLang="en-US" sz="15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19080449-209F-F53C-72A8-920381D94379}"/>
              </a:ext>
            </a:extLst>
          </p:cNvPr>
          <p:cNvSpPr/>
          <p:nvPr/>
        </p:nvSpPr>
        <p:spPr>
          <a:xfrm>
            <a:off x="6862003" y="1336092"/>
            <a:ext cx="349830" cy="287200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5B77D020-F95F-E769-B9F4-F542BEDED7AB}"/>
              </a:ext>
            </a:extLst>
          </p:cNvPr>
          <p:cNvSpPr txBox="1"/>
          <p:nvPr/>
        </p:nvSpPr>
        <p:spPr>
          <a:xfrm rot="16200000">
            <a:off x="5463966" y="2525678"/>
            <a:ext cx="3172570" cy="3231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500" dirty="0">
                <a:latin typeface="Calibri" panose="020F0502020204030204" pitchFamily="34" charset="0"/>
                <a:cs typeface="Calibri" panose="020F0502020204030204" pitchFamily="34" charset="0"/>
              </a:rPr>
              <a:t>Probability </a:t>
            </a:r>
            <a:r>
              <a:rPr lang="en-US" altLang="ja-JP" sz="1500" dirty="0">
                <a:latin typeface="Calibri" panose="020F0502020204030204" pitchFamily="34" charset="0"/>
                <a:cs typeface="Calibri" panose="020F0502020204030204" pitchFamily="34" charset="0"/>
              </a:rPr>
              <a:t>o</a:t>
            </a:r>
            <a:r>
              <a:rPr kumimoji="1" lang="en-US" altLang="ja-JP" sz="1500" dirty="0">
                <a:latin typeface="Calibri" panose="020F0502020204030204" pitchFamily="34" charset="0"/>
                <a:cs typeface="Calibri" panose="020F0502020204030204" pitchFamily="34" charset="0"/>
              </a:rPr>
              <a:t>f </a:t>
            </a:r>
            <a:r>
              <a:rPr lang="en-US" altLang="ja-JP" sz="1500" dirty="0">
                <a:latin typeface="Calibri" panose="020F0502020204030204" pitchFamily="34" charset="0"/>
                <a:cs typeface="Calibri" panose="020F0502020204030204" pitchFamily="34" charset="0"/>
              </a:rPr>
              <a:t>overall</a:t>
            </a:r>
            <a:r>
              <a:rPr kumimoji="1" lang="en-US" altLang="ja-JP" sz="1500" dirty="0">
                <a:latin typeface="Calibri" panose="020F0502020204030204" pitchFamily="34" charset="0"/>
                <a:cs typeface="Calibri" panose="020F0502020204030204" pitchFamily="34" charset="0"/>
              </a:rPr>
              <a:t> survival</a:t>
            </a:r>
            <a:endParaRPr kumimoji="1" lang="ja-JP" altLang="en-US" sz="15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503CA4A-1C0B-E378-41E4-2289DD405CF4}"/>
              </a:ext>
            </a:extLst>
          </p:cNvPr>
          <p:cNvSpPr txBox="1"/>
          <p:nvPr/>
        </p:nvSpPr>
        <p:spPr>
          <a:xfrm>
            <a:off x="372737" y="42813"/>
            <a:ext cx="615625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</a:p>
          <a:p>
            <a:endParaRPr lang="en-US" altLang="ja-JP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kumimoji="1"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r</a:t>
            </a:r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gression free survival</a:t>
            </a:r>
            <a:r>
              <a:rPr lang="ja-JP" alt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patients with UGT1A1*1/*6 and in those with UGT1A1*1/*28.</a:t>
            </a:r>
            <a:endParaRPr kumimoji="1" lang="ja-JP" altLang="en-US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2" name="表 31">
            <a:extLst>
              <a:ext uri="{FF2B5EF4-FFF2-40B4-BE49-F238E27FC236}">
                <a16:creationId xmlns:a16="http://schemas.microsoft.com/office/drawing/2014/main" id="{C7879F37-9898-73E6-9C9B-B5FEC5BAE96D}"/>
              </a:ext>
            </a:extLst>
          </p:cNvPr>
          <p:cNvGraphicFramePr>
            <a:graphicFrameLocks noGrp="1"/>
          </p:cNvGraphicFramePr>
          <p:nvPr/>
        </p:nvGraphicFramePr>
        <p:xfrm>
          <a:off x="1556084" y="4723201"/>
          <a:ext cx="4037735" cy="77653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10595">
                  <a:extLst>
                    <a:ext uri="{9D8B030D-6E8A-4147-A177-3AD203B41FA5}">
                      <a16:colId xmlns:a16="http://schemas.microsoft.com/office/drawing/2014/main" val="2535621530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3411940661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890338278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3076513399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1312221383"/>
                    </a:ext>
                  </a:extLst>
                </a:gridCol>
                <a:gridCol w="296025">
                  <a:extLst>
                    <a:ext uri="{9D8B030D-6E8A-4147-A177-3AD203B41FA5}">
                      <a16:colId xmlns:a16="http://schemas.microsoft.com/office/drawing/2014/main" val="2358118297"/>
                    </a:ext>
                  </a:extLst>
                </a:gridCol>
                <a:gridCol w="325165">
                  <a:extLst>
                    <a:ext uri="{9D8B030D-6E8A-4147-A177-3AD203B41FA5}">
                      <a16:colId xmlns:a16="http://schemas.microsoft.com/office/drawing/2014/main" val="2822790575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3219059813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351302118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365439652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1759902204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717872609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1162334491"/>
                    </a:ext>
                  </a:extLst>
                </a:gridCol>
              </a:tblGrid>
              <a:tr h="31321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10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6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5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4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2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3707802"/>
                  </a:ext>
                </a:extLst>
              </a:tr>
              <a:tr h="23166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12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9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3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2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3927445"/>
                  </a:ext>
                </a:extLst>
              </a:tr>
              <a:tr h="231660"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0626305"/>
                  </a:ext>
                </a:extLst>
              </a:tr>
            </a:tbl>
          </a:graphicData>
        </a:graphic>
      </p:graphicFrame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D79CB42-E6EC-4A38-2324-CAC3BABDCA2A}"/>
              </a:ext>
            </a:extLst>
          </p:cNvPr>
          <p:cNvSpPr txBox="1"/>
          <p:nvPr/>
        </p:nvSpPr>
        <p:spPr>
          <a:xfrm>
            <a:off x="9864184" y="1367644"/>
            <a:ext cx="132440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ea typeface="Meiryo" panose="020B0604030504040204" pitchFamily="34" charset="-128"/>
                <a:cs typeface="Calibri" panose="020F0502020204030204" pitchFamily="34" charset="0"/>
              </a:rPr>
              <a:t>*1/*28(n=10)</a:t>
            </a:r>
          </a:p>
          <a:p>
            <a:r>
              <a:rPr lang="en-US" altLang="ja-JP" sz="1600" dirty="0">
                <a:latin typeface="Calibri" panose="020F0502020204030204" pitchFamily="34" charset="0"/>
                <a:ea typeface="Meiryo" panose="020B0604030504040204" pitchFamily="34" charset="-128"/>
                <a:cs typeface="Calibri" panose="020F0502020204030204" pitchFamily="34" charset="0"/>
              </a:rPr>
              <a:t>*1/*6 (n=12) </a:t>
            </a:r>
          </a:p>
        </p:txBody>
      </p:sp>
      <p:graphicFrame>
        <p:nvGraphicFramePr>
          <p:cNvPr id="43" name="表 42">
            <a:extLst>
              <a:ext uri="{FF2B5EF4-FFF2-40B4-BE49-F238E27FC236}">
                <a16:creationId xmlns:a16="http://schemas.microsoft.com/office/drawing/2014/main" id="{71B880B2-9A5A-582D-A123-BC9C33A9443C}"/>
              </a:ext>
            </a:extLst>
          </p:cNvPr>
          <p:cNvGraphicFramePr>
            <a:graphicFrameLocks noGrp="1"/>
          </p:cNvGraphicFramePr>
          <p:nvPr/>
        </p:nvGraphicFramePr>
        <p:xfrm>
          <a:off x="5593819" y="4747014"/>
          <a:ext cx="1884878" cy="103382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84878">
                  <a:extLst>
                    <a:ext uri="{9D8B030D-6E8A-4147-A177-3AD203B41FA5}">
                      <a16:colId xmlns:a16="http://schemas.microsoft.com/office/drawing/2014/main" val="2535621530"/>
                    </a:ext>
                  </a:extLst>
                </a:gridCol>
              </a:tblGrid>
              <a:tr h="267956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*1/*28</a:t>
                      </a:r>
                    </a:p>
                  </a:txBody>
                  <a:tcPr marL="4763" marR="4763" marT="4763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3707802"/>
                  </a:ext>
                </a:extLst>
              </a:tr>
              <a:tr h="255289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*1/*6</a:t>
                      </a:r>
                    </a:p>
                  </a:txBody>
                  <a:tcPr marL="4763" marR="4763" marT="4763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3927445"/>
                  </a:ext>
                </a:extLst>
              </a:tr>
              <a:tr h="255289">
                <a:tc>
                  <a:txBody>
                    <a:bodyPr/>
                    <a:lstStyle/>
                    <a:p>
                      <a:pPr algn="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2513185"/>
                  </a:ext>
                </a:extLst>
              </a:tr>
              <a:tr h="255289">
                <a:tc>
                  <a:txBody>
                    <a:bodyPr/>
                    <a:lstStyle/>
                    <a:p>
                      <a:pPr algn="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5671373"/>
                  </a:ext>
                </a:extLst>
              </a:tr>
            </a:tbl>
          </a:graphicData>
        </a:graphic>
      </p:graphicFrame>
      <p:graphicFrame>
        <p:nvGraphicFramePr>
          <p:cNvPr id="46" name="表 45">
            <a:extLst>
              <a:ext uri="{FF2B5EF4-FFF2-40B4-BE49-F238E27FC236}">
                <a16:creationId xmlns:a16="http://schemas.microsoft.com/office/drawing/2014/main" id="{B06E8C9C-1917-A77C-A45A-6D7EC1FECE1E}"/>
              </a:ext>
            </a:extLst>
          </p:cNvPr>
          <p:cNvGraphicFramePr>
            <a:graphicFrameLocks noGrp="1"/>
          </p:cNvGraphicFramePr>
          <p:nvPr/>
        </p:nvGraphicFramePr>
        <p:xfrm>
          <a:off x="7594598" y="4698809"/>
          <a:ext cx="4037735" cy="77653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10595">
                  <a:extLst>
                    <a:ext uri="{9D8B030D-6E8A-4147-A177-3AD203B41FA5}">
                      <a16:colId xmlns:a16="http://schemas.microsoft.com/office/drawing/2014/main" val="2535621530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3411940661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890338278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3076513399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1312221383"/>
                    </a:ext>
                  </a:extLst>
                </a:gridCol>
                <a:gridCol w="296025">
                  <a:extLst>
                    <a:ext uri="{9D8B030D-6E8A-4147-A177-3AD203B41FA5}">
                      <a16:colId xmlns:a16="http://schemas.microsoft.com/office/drawing/2014/main" val="2358118297"/>
                    </a:ext>
                  </a:extLst>
                </a:gridCol>
                <a:gridCol w="325165">
                  <a:extLst>
                    <a:ext uri="{9D8B030D-6E8A-4147-A177-3AD203B41FA5}">
                      <a16:colId xmlns:a16="http://schemas.microsoft.com/office/drawing/2014/main" val="2822790575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3219059813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351302118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365439652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1759902204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717872609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1162334491"/>
                    </a:ext>
                  </a:extLst>
                </a:gridCol>
              </a:tblGrid>
              <a:tr h="31321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10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9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8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6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4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2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3707802"/>
                  </a:ext>
                </a:extLst>
              </a:tr>
              <a:tr h="23166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12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12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10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7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2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3927445"/>
                  </a:ext>
                </a:extLst>
              </a:tr>
              <a:tr h="231660"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0626305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8A94DA4-91B0-5517-BA64-90C275325C0A}"/>
              </a:ext>
            </a:extLst>
          </p:cNvPr>
          <p:cNvSpPr txBox="1"/>
          <p:nvPr/>
        </p:nvSpPr>
        <p:spPr>
          <a:xfrm>
            <a:off x="6222940" y="597004"/>
            <a:ext cx="56740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kumimoji="1"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</a:t>
            </a:r>
            <a:r>
              <a:rPr lang="ja-JP" alt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patients with UGT1A1*1/*6 and in those with UGT1A1*1/*28.</a:t>
            </a:r>
            <a:endParaRPr kumimoji="1" lang="ja-JP" altLang="en-US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461510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CFCBB15-299A-5124-83E4-7125E9570556}"/>
              </a:ext>
            </a:extLst>
          </p:cNvPr>
          <p:cNvSpPr txBox="1"/>
          <p:nvPr/>
        </p:nvSpPr>
        <p:spPr>
          <a:xfrm>
            <a:off x="144074" y="203378"/>
            <a:ext cx="888860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Table S3. Treatment details for </a:t>
            </a:r>
            <a:r>
              <a:rPr lang="en-US" altLang="ja-JP" b="1" i="1" dirty="0">
                <a:latin typeface="Times New Roman" panose="02020603050405020304" pitchFamily="18" charset="0"/>
                <a:ea typeface="游明朝" panose="02020400000000000000" pitchFamily="18" charset="-128"/>
              </a:rPr>
              <a:t>patients with UGT1A1 double variants</a:t>
            </a:r>
            <a:endParaRPr lang="ja-JP" altLang="en-US" dirty="0"/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D37D0F06-7D28-2E05-5957-CAAB53D52D6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4738082"/>
              </p:ext>
            </p:extLst>
          </p:nvPr>
        </p:nvGraphicFramePr>
        <p:xfrm>
          <a:off x="3215050" y="1104564"/>
          <a:ext cx="5761899" cy="4247863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2024666">
                  <a:extLst>
                    <a:ext uri="{9D8B030D-6E8A-4147-A177-3AD203B41FA5}">
                      <a16:colId xmlns:a16="http://schemas.microsoft.com/office/drawing/2014/main" val="3496476257"/>
                    </a:ext>
                  </a:extLst>
                </a:gridCol>
                <a:gridCol w="1463365">
                  <a:extLst>
                    <a:ext uri="{9D8B030D-6E8A-4147-A177-3AD203B41FA5}">
                      <a16:colId xmlns:a16="http://schemas.microsoft.com/office/drawing/2014/main" val="1948511566"/>
                    </a:ext>
                  </a:extLst>
                </a:gridCol>
                <a:gridCol w="1136934">
                  <a:extLst>
                    <a:ext uri="{9D8B030D-6E8A-4147-A177-3AD203B41FA5}">
                      <a16:colId xmlns:a16="http://schemas.microsoft.com/office/drawing/2014/main" val="2965657010"/>
                    </a:ext>
                  </a:extLst>
                </a:gridCol>
                <a:gridCol w="1136934">
                  <a:extLst>
                    <a:ext uri="{9D8B030D-6E8A-4147-A177-3AD203B41FA5}">
                      <a16:colId xmlns:a16="http://schemas.microsoft.com/office/drawing/2014/main" val="1799997221"/>
                    </a:ext>
                  </a:extLst>
                </a:gridCol>
              </a:tblGrid>
              <a:tr h="505698">
                <a:tc>
                  <a:txBody>
                    <a:bodyPr/>
                    <a:lstStyle/>
                    <a:p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UGT1A1 *6/*6 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or </a:t>
                      </a:r>
                      <a:r>
                        <a:rPr kumimoji="1" lang="en-US" altLang="ja-JP" sz="12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*6/*28</a:t>
                      </a:r>
                      <a:endParaRPr kumimoji="1" lang="en-US" altLang="ja-JP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n=3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1" dirty="0"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1516103"/>
                  </a:ext>
                </a:extLst>
              </a:tr>
              <a:tr h="303419">
                <a:tc>
                  <a:txBody>
                    <a:bodyPr/>
                    <a:lstStyle/>
                    <a:p>
                      <a:endParaRPr kumimoji="1" lang="ja-JP" alt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nal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-IRI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5-FU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0044052"/>
                  </a:ext>
                </a:extLst>
              </a:tr>
              <a:tr h="505698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Received cycles</a:t>
                      </a:r>
                    </a:p>
                  </a:txBody>
                  <a:tcPr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Median</a:t>
                      </a:r>
                      <a:r>
                        <a:rPr kumimoji="1" lang="ja-JP" alt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(range)</a:t>
                      </a:r>
                    </a:p>
                    <a:p>
                      <a:pPr algn="l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Total</a:t>
                      </a:r>
                      <a:r>
                        <a:rPr kumimoji="1" lang="ja-JP" alt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cycles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2(3-19)</a:t>
                      </a:r>
                    </a:p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34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7594697"/>
                  </a:ext>
                </a:extLst>
              </a:tr>
              <a:tr h="505698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Starting</a:t>
                      </a:r>
                      <a:r>
                        <a:rPr kumimoji="1" lang="ja-JP" alt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dose</a:t>
                      </a:r>
                    </a:p>
                  </a:txBody>
                  <a:tcPr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Full</a:t>
                      </a:r>
                    </a:p>
                    <a:p>
                      <a:pPr algn="l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Reduced</a:t>
                      </a:r>
                    </a:p>
                  </a:txBody>
                  <a:tcPr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3 (100.0%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3 (100.0%)</a:t>
                      </a:r>
                    </a:p>
                    <a:p>
                      <a:pPr algn="ctr"/>
                      <a:r>
                        <a:rPr kumimoji="1" lang="en-US" altLang="ja-JP" sz="12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0453747"/>
                  </a:ext>
                </a:extLst>
              </a:tr>
              <a:tr h="505698">
                <a:tc gridSpan="2"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Median Starting</a:t>
                      </a:r>
                      <a:r>
                        <a:rPr kumimoji="1" lang="ja-JP" alt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dose</a:t>
                      </a:r>
                    </a:p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(range)</a:t>
                      </a:r>
                    </a:p>
                  </a:txBody>
                  <a:tcPr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en-US" altLang="ja-JP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50 mg/m</a:t>
                      </a:r>
                      <a:r>
                        <a:rPr kumimoji="1" lang="en-US" altLang="ja-JP" sz="1200" b="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pPr algn="ctr"/>
                      <a:r>
                        <a:rPr kumimoji="1" lang="en-US" altLang="ja-JP" sz="12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(42-50)</a:t>
                      </a:r>
                      <a:endParaRPr kumimoji="1" lang="ja-JP" altLang="en-US" sz="1200" b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2400 mg/m</a:t>
                      </a:r>
                      <a:r>
                        <a:rPr kumimoji="1" lang="en-US" altLang="ja-JP" sz="1200" b="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2</a:t>
                      </a:r>
                      <a:endParaRPr kumimoji="1" lang="en-US" altLang="ja-JP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(2400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727325"/>
                  </a:ext>
                </a:extLst>
              </a:tr>
              <a:tr h="505698">
                <a:tc>
                  <a:txBody>
                    <a:bodyPr/>
                    <a:lstStyle/>
                    <a:p>
                      <a:r>
                        <a:rPr kumimoji="1" lang="en-US" altLang="ja-JP" sz="12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Dose</a:t>
                      </a:r>
                      <a:r>
                        <a:rPr kumimoji="1" lang="ja-JP" altLang="en-US" sz="12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reduction</a:t>
                      </a:r>
                      <a:r>
                        <a:rPr kumimoji="1" lang="ja-JP" altLang="en-US" sz="12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in</a:t>
                      </a:r>
                    </a:p>
                    <a:p>
                      <a:r>
                        <a:rPr kumimoji="1" lang="en-US" altLang="ja-JP" sz="12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subsequent cycles</a:t>
                      </a:r>
                    </a:p>
                  </a:txBody>
                  <a:tcPr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ja-JP" alt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≥</a:t>
                      </a: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ja-JP" alt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times</a:t>
                      </a:r>
                    </a:p>
                    <a:p>
                      <a:pPr algn="l"/>
                      <a:r>
                        <a:rPr kumimoji="1" lang="ja-JP" alt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≥</a:t>
                      </a: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2 times </a:t>
                      </a:r>
                    </a:p>
                  </a:txBody>
                  <a:tcPr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2 (66.7%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 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26963441"/>
                  </a:ext>
                </a:extLst>
              </a:tr>
              <a:tr h="910256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Reason</a:t>
                      </a:r>
                      <a:r>
                        <a:rPr kumimoji="1" lang="ja-JP" alt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for</a:t>
                      </a:r>
                      <a:r>
                        <a:rPr kumimoji="1" lang="ja-JP" alt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</a:t>
                      </a:r>
                      <a:endParaRPr kumimoji="1" lang="en-US" altLang="ja-JP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dose</a:t>
                      </a:r>
                      <a:r>
                        <a:rPr kumimoji="1" lang="ja-JP" alt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reduction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Neutropenia</a:t>
                      </a:r>
                      <a:endParaRPr kumimoji="1" lang="en-US" altLang="ja-JP" sz="1200" b="0" baseline="0" dirty="0">
                        <a:ln w="10160">
                          <a:solidFill>
                            <a:srgbClr val="0000FF"/>
                          </a:solidFill>
                          <a:prstDash val="solid"/>
                        </a:ln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  <a:p>
                      <a:pPr algn="l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Anorexia</a:t>
                      </a:r>
                    </a:p>
                    <a:p>
                      <a:pPr algn="l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Fatigue</a:t>
                      </a:r>
                    </a:p>
                    <a:p>
                      <a:pPr algn="l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Other</a:t>
                      </a:r>
                    </a:p>
                  </a:txBody>
                  <a:tcPr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2 (66.7%)</a:t>
                      </a:r>
                    </a:p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 (33.3%)</a:t>
                      </a:r>
                    </a:p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2 (66.7%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 </a:t>
                      </a:r>
                    </a:p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 </a:t>
                      </a:r>
                    </a:p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 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76730660"/>
                  </a:ext>
                </a:extLst>
              </a:tr>
              <a:tr h="505698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Relative dose intensity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Median</a:t>
                      </a:r>
                    </a:p>
                    <a:p>
                      <a:pPr algn="l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(range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.53</a:t>
                      </a:r>
                    </a:p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(0.35-0.58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.82</a:t>
                      </a:r>
                    </a:p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(0.70-0.85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010522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921878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88B2A07-D497-2FA8-713A-18BD73F58CA0}"/>
              </a:ext>
            </a:extLst>
          </p:cNvPr>
          <p:cNvSpPr txBox="1"/>
          <p:nvPr/>
        </p:nvSpPr>
        <p:spPr>
          <a:xfrm>
            <a:off x="144074" y="203378"/>
            <a:ext cx="888860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Table S4. </a:t>
            </a:r>
            <a:r>
              <a:rPr kumimoji="1"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verse events</a:t>
            </a:r>
            <a:r>
              <a:rPr lang="en-US" altLang="ja-JP" sz="1800" b="1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for </a:t>
            </a:r>
            <a:r>
              <a:rPr lang="en-US" altLang="ja-JP" b="1" i="1" dirty="0">
                <a:latin typeface="Times New Roman" panose="02020603050405020304" pitchFamily="18" charset="0"/>
                <a:ea typeface="游明朝" panose="02020400000000000000" pitchFamily="18" charset="-128"/>
              </a:rPr>
              <a:t>patients with UGT1A1 double variants</a:t>
            </a:r>
            <a:endParaRPr lang="ja-JP" altLang="en-US" dirty="0"/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D6E38970-BE56-288A-5FFF-E6579EE17AE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0905405"/>
              </p:ext>
            </p:extLst>
          </p:nvPr>
        </p:nvGraphicFramePr>
        <p:xfrm>
          <a:off x="2789111" y="572710"/>
          <a:ext cx="6905158" cy="616599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851343">
                  <a:extLst>
                    <a:ext uri="{9D8B030D-6E8A-4147-A177-3AD203B41FA5}">
                      <a16:colId xmlns:a16="http://schemas.microsoft.com/office/drawing/2014/main" val="3496476257"/>
                    </a:ext>
                  </a:extLst>
                </a:gridCol>
                <a:gridCol w="1283337">
                  <a:extLst>
                    <a:ext uri="{9D8B030D-6E8A-4147-A177-3AD203B41FA5}">
                      <a16:colId xmlns:a16="http://schemas.microsoft.com/office/drawing/2014/main" val="2965657010"/>
                    </a:ext>
                  </a:extLst>
                </a:gridCol>
                <a:gridCol w="1321822">
                  <a:extLst>
                    <a:ext uri="{9D8B030D-6E8A-4147-A177-3AD203B41FA5}">
                      <a16:colId xmlns:a16="http://schemas.microsoft.com/office/drawing/2014/main" val="1799997221"/>
                    </a:ext>
                  </a:extLst>
                </a:gridCol>
                <a:gridCol w="1283337">
                  <a:extLst>
                    <a:ext uri="{9D8B030D-6E8A-4147-A177-3AD203B41FA5}">
                      <a16:colId xmlns:a16="http://schemas.microsoft.com/office/drawing/2014/main" val="1960411450"/>
                    </a:ext>
                  </a:extLst>
                </a:gridCol>
                <a:gridCol w="1165319">
                  <a:extLst>
                    <a:ext uri="{9D8B030D-6E8A-4147-A177-3AD203B41FA5}">
                      <a16:colId xmlns:a16="http://schemas.microsoft.com/office/drawing/2014/main" val="2642112790"/>
                    </a:ext>
                  </a:extLst>
                </a:gridCol>
              </a:tblGrid>
              <a:tr h="405270">
                <a:tc>
                  <a:txBody>
                    <a:bodyPr/>
                    <a:lstStyle/>
                    <a:p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*6/*6 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or </a:t>
                      </a:r>
                      <a:r>
                        <a:rPr kumimoji="1" lang="en-US" altLang="ja-JP" sz="12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*6/*28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(n=3)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1" dirty="0"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value (</a:t>
                      </a:r>
                      <a:r>
                        <a:rPr kumimoji="1" lang="en-US" altLang="ja-JP" sz="12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*1/*1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vs </a:t>
                      </a:r>
                      <a:r>
                        <a:rPr kumimoji="1" lang="en-US" altLang="ja-JP" sz="12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*6/*6 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or </a:t>
                      </a:r>
                      <a:r>
                        <a:rPr kumimoji="1" lang="en-US" altLang="ja-JP" sz="12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*6/*28</a:t>
                      </a: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)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b="1" dirty="0"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1516103"/>
                  </a:ext>
                </a:extLst>
              </a:tr>
              <a:tr h="266200">
                <a:tc>
                  <a:txBody>
                    <a:bodyPr/>
                    <a:lstStyle/>
                    <a:p>
                      <a:endParaRPr kumimoji="1" lang="ja-JP" alt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All grade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≥</a:t>
                      </a: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grade3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All grade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≥</a:t>
                      </a: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grade3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0044052"/>
                  </a:ext>
                </a:extLst>
              </a:tr>
              <a:tr h="266200">
                <a:tc>
                  <a:txBody>
                    <a:bodyPr/>
                    <a:lstStyle/>
                    <a:p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Hematological AEs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7594697"/>
                  </a:ext>
                </a:extLst>
              </a:tr>
              <a:tr h="266200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ja-JP" alt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Leucopenia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2(66.7%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(33.3%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.0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.52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727325"/>
                  </a:ext>
                </a:extLst>
              </a:tr>
              <a:tr h="266200"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 Neutropenia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2(66.7%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2(66.7%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.0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.27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26963441"/>
                  </a:ext>
                </a:extLst>
              </a:tr>
              <a:tr h="266200">
                <a:tc>
                  <a:txBody>
                    <a:bodyPr/>
                    <a:lstStyle/>
                    <a:p>
                      <a:pPr marL="12700" indent="0" algn="l">
                        <a:tabLst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 Anemia</a:t>
                      </a: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3(100%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.0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.0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76730660"/>
                  </a:ext>
                </a:extLst>
              </a:tr>
              <a:tr h="2662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 Thrombocytopenia</a:t>
                      </a: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2(66.7%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.55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.0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0105220"/>
                  </a:ext>
                </a:extLst>
              </a:tr>
              <a:tr h="2662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Non-Hematological AEs</a:t>
                      </a: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2957742"/>
                  </a:ext>
                </a:extLst>
              </a:tr>
              <a:tr h="26620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 AST</a:t>
                      </a:r>
                      <a:r>
                        <a:rPr kumimoji="1" lang="ja-JP" altLang="en-US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increased</a:t>
                      </a: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(33.3%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.0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17771249"/>
                  </a:ext>
                </a:extLst>
              </a:tr>
              <a:tr h="26620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 ALT increased</a:t>
                      </a: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.53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0314664"/>
                  </a:ext>
                </a:extLst>
              </a:tr>
              <a:tr h="26620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 Blood bilirubin increased</a:t>
                      </a: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.0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919294"/>
                  </a:ext>
                </a:extLst>
              </a:tr>
              <a:tr h="26620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 Creatinine increased</a:t>
                      </a: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.0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.0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2467064"/>
                  </a:ext>
                </a:extLst>
              </a:tr>
              <a:tr h="2662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 Fatigue</a:t>
                      </a: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3(100%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.56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.0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5307094"/>
                  </a:ext>
                </a:extLst>
              </a:tr>
              <a:tr h="2662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 Nausea</a:t>
                      </a: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3(100%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.54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.0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40084018"/>
                  </a:ext>
                </a:extLst>
              </a:tr>
              <a:tr h="2662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 Vomiting</a:t>
                      </a: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(33.3%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.29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1563136"/>
                  </a:ext>
                </a:extLst>
              </a:tr>
              <a:tr h="2662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 Anorexia</a:t>
                      </a: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3(100%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.53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.0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2419451"/>
                  </a:ext>
                </a:extLst>
              </a:tr>
              <a:tr h="2662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 Diarrhea</a:t>
                      </a: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2(66.7%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.0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‐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3411327"/>
                  </a:ext>
                </a:extLst>
              </a:tr>
              <a:tr h="2662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 Febrile neutropenia</a:t>
                      </a: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(33.3%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.1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39944496"/>
                  </a:ext>
                </a:extLst>
              </a:tr>
              <a:tr h="2662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 Alopecia</a:t>
                      </a: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3(100%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.22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1426316"/>
                  </a:ext>
                </a:extLst>
              </a:tr>
              <a:tr h="2662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 Mucositis oral</a:t>
                      </a: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.0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11570624"/>
                  </a:ext>
                </a:extLst>
              </a:tr>
              <a:tr h="2662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 Intestinal lung disease </a:t>
                      </a: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.0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96448245"/>
                  </a:ext>
                </a:extLst>
              </a:tr>
              <a:tr h="2662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  Biliary tract infection</a:t>
                      </a: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.0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eiryo" panose="020B0604030504040204" pitchFamily="34" charset="-128"/>
                          <a:cs typeface="Times New Roman" panose="02020603050405020304" pitchFamily="18" charset="0"/>
                        </a:rPr>
                        <a:t>1.0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eiryo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339016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028307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:a16="http://schemas.microsoft.com/office/drawing/2014/main" id="{943FA783-F5D7-53DF-F3B5-446CDE63AB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8017" y="1383798"/>
            <a:ext cx="1000133" cy="2664638"/>
          </a:xfrm>
          <a:prstGeom prst="rect">
            <a:avLst/>
          </a:prstGeom>
        </p:spPr>
      </p:pic>
      <p:graphicFrame>
        <p:nvGraphicFramePr>
          <p:cNvPr id="12" name="表 11">
            <a:extLst>
              <a:ext uri="{FF2B5EF4-FFF2-40B4-BE49-F238E27FC236}">
                <a16:creationId xmlns:a16="http://schemas.microsoft.com/office/drawing/2014/main" id="{CF9185CB-606A-B32B-BD85-556CBBFB48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39850298"/>
              </p:ext>
            </p:extLst>
          </p:nvPr>
        </p:nvGraphicFramePr>
        <p:xfrm>
          <a:off x="-324015" y="4699348"/>
          <a:ext cx="1884878" cy="51057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84878">
                  <a:extLst>
                    <a:ext uri="{9D8B030D-6E8A-4147-A177-3AD203B41FA5}">
                      <a16:colId xmlns:a16="http://schemas.microsoft.com/office/drawing/2014/main" val="2535621530"/>
                    </a:ext>
                  </a:extLst>
                </a:gridCol>
              </a:tblGrid>
              <a:tr h="255289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Double variant</a:t>
                      </a:r>
                    </a:p>
                  </a:txBody>
                  <a:tcPr marL="4763" marR="4763" marT="4763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2513185"/>
                  </a:ext>
                </a:extLst>
              </a:tr>
              <a:tr h="255289">
                <a:tc>
                  <a:txBody>
                    <a:bodyPr/>
                    <a:lstStyle/>
                    <a:p>
                      <a:pPr algn="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5671373"/>
                  </a:ext>
                </a:extLst>
              </a:tr>
            </a:tbl>
          </a:graphicData>
        </a:graphic>
      </p:graphicFrame>
      <p:graphicFrame>
        <p:nvGraphicFramePr>
          <p:cNvPr id="13" name="表 12">
            <a:extLst>
              <a:ext uri="{FF2B5EF4-FFF2-40B4-BE49-F238E27FC236}">
                <a16:creationId xmlns:a16="http://schemas.microsoft.com/office/drawing/2014/main" id="{5519E056-87E8-C99E-D6B9-D021618B214B}"/>
              </a:ext>
            </a:extLst>
          </p:cNvPr>
          <p:cNvGraphicFramePr>
            <a:graphicFrameLocks noGrp="1"/>
          </p:cNvGraphicFramePr>
          <p:nvPr/>
        </p:nvGraphicFramePr>
        <p:xfrm>
          <a:off x="1597211" y="4474634"/>
          <a:ext cx="1853652" cy="22415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53652">
                  <a:extLst>
                    <a:ext uri="{9D8B030D-6E8A-4147-A177-3AD203B41FA5}">
                      <a16:colId xmlns:a16="http://schemas.microsoft.com/office/drawing/2014/main" val="2535621530"/>
                    </a:ext>
                  </a:extLst>
                </a:gridCol>
              </a:tblGrid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No at risk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3927445"/>
                  </a:ext>
                </a:extLst>
              </a:tr>
            </a:tbl>
          </a:graphicData>
        </a:graphic>
      </p:graphicFrame>
      <p:pic>
        <p:nvPicPr>
          <p:cNvPr id="16" name="図 15">
            <a:extLst>
              <a:ext uri="{FF2B5EF4-FFF2-40B4-BE49-F238E27FC236}">
                <a16:creationId xmlns:a16="http://schemas.microsoft.com/office/drawing/2014/main" id="{EE12E004-70FD-E3B8-F666-16D61772373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90684" y="3982727"/>
            <a:ext cx="4093398" cy="514355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7EBA5801-7058-F51F-6F69-92DC7FDC5B1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62003" y="1407043"/>
            <a:ext cx="885831" cy="2664638"/>
          </a:xfrm>
          <a:prstGeom prst="rect">
            <a:avLst/>
          </a:prstGeom>
        </p:spPr>
      </p:pic>
      <p:graphicFrame>
        <p:nvGraphicFramePr>
          <p:cNvPr id="18" name="表 17">
            <a:extLst>
              <a:ext uri="{FF2B5EF4-FFF2-40B4-BE49-F238E27FC236}">
                <a16:creationId xmlns:a16="http://schemas.microsoft.com/office/drawing/2014/main" id="{07090E05-572A-BD0A-F5DD-E824497AC7C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2936204"/>
              </p:ext>
            </p:extLst>
          </p:nvPr>
        </p:nvGraphicFramePr>
        <p:xfrm>
          <a:off x="7587321" y="4712229"/>
          <a:ext cx="4037735" cy="23751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10595">
                  <a:extLst>
                    <a:ext uri="{9D8B030D-6E8A-4147-A177-3AD203B41FA5}">
                      <a16:colId xmlns:a16="http://schemas.microsoft.com/office/drawing/2014/main" val="2535621530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3411940661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890338278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3076513399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1312221383"/>
                    </a:ext>
                  </a:extLst>
                </a:gridCol>
                <a:gridCol w="296025">
                  <a:extLst>
                    <a:ext uri="{9D8B030D-6E8A-4147-A177-3AD203B41FA5}">
                      <a16:colId xmlns:a16="http://schemas.microsoft.com/office/drawing/2014/main" val="2358118297"/>
                    </a:ext>
                  </a:extLst>
                </a:gridCol>
                <a:gridCol w="325165">
                  <a:extLst>
                    <a:ext uri="{9D8B030D-6E8A-4147-A177-3AD203B41FA5}">
                      <a16:colId xmlns:a16="http://schemas.microsoft.com/office/drawing/2014/main" val="2822790575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3219059813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351302118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365439652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1759902204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717872609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1162334491"/>
                    </a:ext>
                  </a:extLst>
                </a:gridCol>
              </a:tblGrid>
              <a:tr h="23751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3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407751"/>
                  </a:ext>
                </a:extLst>
              </a:tr>
            </a:tbl>
          </a:graphicData>
        </a:graphic>
      </p:graphicFrame>
      <p:graphicFrame>
        <p:nvGraphicFramePr>
          <p:cNvPr id="20" name="表 19">
            <a:extLst>
              <a:ext uri="{FF2B5EF4-FFF2-40B4-BE49-F238E27FC236}">
                <a16:creationId xmlns:a16="http://schemas.microsoft.com/office/drawing/2014/main" id="{E993E81A-F9ED-599D-BC59-9719EB36D139}"/>
              </a:ext>
            </a:extLst>
          </p:cNvPr>
          <p:cNvGraphicFramePr>
            <a:graphicFrameLocks noGrp="1"/>
          </p:cNvGraphicFramePr>
          <p:nvPr/>
        </p:nvGraphicFramePr>
        <p:xfrm>
          <a:off x="7582669" y="4465278"/>
          <a:ext cx="1853652" cy="22415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53652">
                  <a:extLst>
                    <a:ext uri="{9D8B030D-6E8A-4147-A177-3AD203B41FA5}">
                      <a16:colId xmlns:a16="http://schemas.microsoft.com/office/drawing/2014/main" val="2535621530"/>
                    </a:ext>
                  </a:extLst>
                </a:gridCol>
              </a:tblGrid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No at risk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3927445"/>
                  </a:ext>
                </a:extLst>
              </a:tr>
            </a:tbl>
          </a:graphicData>
        </a:graphic>
      </p:graphicFrame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A54F3881-63BC-6E59-6960-EDC63203151B}"/>
              </a:ext>
            </a:extLst>
          </p:cNvPr>
          <p:cNvSpPr txBox="1"/>
          <p:nvPr/>
        </p:nvSpPr>
        <p:spPr>
          <a:xfrm rot="16200000">
            <a:off x="-700858" y="2410262"/>
            <a:ext cx="3172570" cy="5539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500" dirty="0">
                <a:latin typeface="Calibri" panose="020F0502020204030204" pitchFamily="34" charset="0"/>
                <a:cs typeface="Calibri" panose="020F0502020204030204" pitchFamily="34" charset="0"/>
              </a:rPr>
              <a:t>Probability </a:t>
            </a:r>
            <a:r>
              <a:rPr lang="en-US" altLang="ja-JP" sz="1500" dirty="0">
                <a:latin typeface="Calibri" panose="020F0502020204030204" pitchFamily="34" charset="0"/>
                <a:cs typeface="Calibri" panose="020F0502020204030204" pitchFamily="34" charset="0"/>
              </a:rPr>
              <a:t>o</a:t>
            </a:r>
            <a:r>
              <a:rPr kumimoji="1" lang="en-US" altLang="ja-JP" sz="1500" dirty="0">
                <a:latin typeface="Calibri" panose="020F0502020204030204" pitchFamily="34" charset="0"/>
                <a:cs typeface="Calibri" panose="020F0502020204030204" pitchFamily="34" charset="0"/>
              </a:rPr>
              <a:t>f </a:t>
            </a:r>
          </a:p>
          <a:p>
            <a:pPr algn="ctr"/>
            <a:r>
              <a:rPr kumimoji="1" lang="en-US" altLang="ja-JP" sz="1500" dirty="0">
                <a:latin typeface="Calibri" panose="020F0502020204030204" pitchFamily="34" charset="0"/>
                <a:cs typeface="Calibri" panose="020F0502020204030204" pitchFamily="34" charset="0"/>
              </a:rPr>
              <a:t>progression free survival</a:t>
            </a:r>
            <a:endParaRPr kumimoji="1" lang="ja-JP" altLang="en-US" sz="15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19080449-209F-F53C-72A8-920381D94379}"/>
              </a:ext>
            </a:extLst>
          </p:cNvPr>
          <p:cNvSpPr/>
          <p:nvPr/>
        </p:nvSpPr>
        <p:spPr>
          <a:xfrm>
            <a:off x="6862003" y="1336092"/>
            <a:ext cx="349830" cy="287200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5B77D020-F95F-E769-B9F4-F542BEDED7AB}"/>
              </a:ext>
            </a:extLst>
          </p:cNvPr>
          <p:cNvSpPr txBox="1"/>
          <p:nvPr/>
        </p:nvSpPr>
        <p:spPr>
          <a:xfrm rot="16200000">
            <a:off x="5463966" y="2525678"/>
            <a:ext cx="3172570" cy="3231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500" dirty="0">
                <a:latin typeface="Calibri" panose="020F0502020204030204" pitchFamily="34" charset="0"/>
                <a:cs typeface="Calibri" panose="020F0502020204030204" pitchFamily="34" charset="0"/>
              </a:rPr>
              <a:t>Probability </a:t>
            </a:r>
            <a:r>
              <a:rPr lang="en-US" altLang="ja-JP" sz="1500" dirty="0">
                <a:latin typeface="Calibri" panose="020F0502020204030204" pitchFamily="34" charset="0"/>
                <a:cs typeface="Calibri" panose="020F0502020204030204" pitchFamily="34" charset="0"/>
              </a:rPr>
              <a:t>o</a:t>
            </a:r>
            <a:r>
              <a:rPr kumimoji="1" lang="en-US" altLang="ja-JP" sz="1500" dirty="0">
                <a:latin typeface="Calibri" panose="020F0502020204030204" pitchFamily="34" charset="0"/>
                <a:cs typeface="Calibri" panose="020F0502020204030204" pitchFamily="34" charset="0"/>
              </a:rPr>
              <a:t>f </a:t>
            </a:r>
            <a:r>
              <a:rPr lang="en-US" altLang="ja-JP" sz="1500" dirty="0">
                <a:latin typeface="Calibri" panose="020F0502020204030204" pitchFamily="34" charset="0"/>
                <a:cs typeface="Calibri" panose="020F0502020204030204" pitchFamily="34" charset="0"/>
              </a:rPr>
              <a:t>overall</a:t>
            </a:r>
            <a:r>
              <a:rPr kumimoji="1" lang="en-US" altLang="ja-JP" sz="1500" dirty="0">
                <a:latin typeface="Calibri" panose="020F0502020204030204" pitchFamily="34" charset="0"/>
                <a:cs typeface="Calibri" panose="020F0502020204030204" pitchFamily="34" charset="0"/>
              </a:rPr>
              <a:t> survival</a:t>
            </a:r>
            <a:endParaRPr kumimoji="1" lang="ja-JP" altLang="en-US" sz="15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503CA4A-1C0B-E378-41E4-2289DD405CF4}"/>
              </a:ext>
            </a:extLst>
          </p:cNvPr>
          <p:cNvSpPr txBox="1"/>
          <p:nvPr/>
        </p:nvSpPr>
        <p:spPr>
          <a:xfrm>
            <a:off x="338186" y="30091"/>
            <a:ext cx="615625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</a:p>
          <a:p>
            <a:endParaRPr lang="en-US" altLang="ja-JP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kumimoji="1"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r</a:t>
            </a:r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gression free survival</a:t>
            </a:r>
            <a:r>
              <a:rPr lang="ja-JP" alt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ja-JP" alt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</a:t>
            </a:r>
            <a:r>
              <a:rPr lang="ja-JP" alt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ja-JP" alt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GT1A1 double variant.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140CC8A-62C1-BD1E-58C7-B464BD8618FB}"/>
              </a:ext>
            </a:extLst>
          </p:cNvPr>
          <p:cNvSpPr txBox="1"/>
          <p:nvPr/>
        </p:nvSpPr>
        <p:spPr>
          <a:xfrm>
            <a:off x="6507770" y="568175"/>
            <a:ext cx="54812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kumimoji="1"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 for patients with UGT1A1 double variant .</a:t>
            </a:r>
            <a:endParaRPr kumimoji="1" lang="ja-JP" altLang="en-US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A8333A67-C498-D402-E9B5-EA37C074489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63650" y="3974331"/>
            <a:ext cx="4093398" cy="514355"/>
          </a:xfrm>
          <a:prstGeom prst="rect">
            <a:avLst/>
          </a:prstGeom>
        </p:spPr>
      </p:pic>
      <p:graphicFrame>
        <p:nvGraphicFramePr>
          <p:cNvPr id="32" name="表 31">
            <a:extLst>
              <a:ext uri="{FF2B5EF4-FFF2-40B4-BE49-F238E27FC236}">
                <a16:creationId xmlns:a16="http://schemas.microsoft.com/office/drawing/2014/main" id="{C7879F37-9898-73E6-9C9B-B5FEC5BAE96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6056569"/>
              </p:ext>
            </p:extLst>
          </p:nvPr>
        </p:nvGraphicFramePr>
        <p:xfrm>
          <a:off x="1562400" y="4723200"/>
          <a:ext cx="4037735" cy="2316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10595">
                  <a:extLst>
                    <a:ext uri="{9D8B030D-6E8A-4147-A177-3AD203B41FA5}">
                      <a16:colId xmlns:a16="http://schemas.microsoft.com/office/drawing/2014/main" val="2535621530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3411940661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890338278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3076513399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1312221383"/>
                    </a:ext>
                  </a:extLst>
                </a:gridCol>
                <a:gridCol w="296025">
                  <a:extLst>
                    <a:ext uri="{9D8B030D-6E8A-4147-A177-3AD203B41FA5}">
                      <a16:colId xmlns:a16="http://schemas.microsoft.com/office/drawing/2014/main" val="2358118297"/>
                    </a:ext>
                  </a:extLst>
                </a:gridCol>
                <a:gridCol w="325165">
                  <a:extLst>
                    <a:ext uri="{9D8B030D-6E8A-4147-A177-3AD203B41FA5}">
                      <a16:colId xmlns:a16="http://schemas.microsoft.com/office/drawing/2014/main" val="2822790575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3219059813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351302118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365439652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1759902204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717872609"/>
                    </a:ext>
                  </a:extLst>
                </a:gridCol>
                <a:gridCol w="310595">
                  <a:extLst>
                    <a:ext uri="{9D8B030D-6E8A-4147-A177-3AD203B41FA5}">
                      <a16:colId xmlns:a16="http://schemas.microsoft.com/office/drawing/2014/main" val="1162334491"/>
                    </a:ext>
                  </a:extLst>
                </a:gridCol>
              </a:tblGrid>
              <a:tr h="23166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3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3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2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2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0</a:t>
                      </a:r>
                    </a:p>
                  </a:txBody>
                  <a:tcPr marL="4763" marR="4763" marT="476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0626305"/>
                  </a:ext>
                </a:extLst>
              </a:tr>
            </a:tbl>
          </a:graphicData>
        </a:graphic>
      </p:graphicFrame>
      <p:graphicFrame>
        <p:nvGraphicFramePr>
          <p:cNvPr id="38" name="表 37">
            <a:extLst>
              <a:ext uri="{FF2B5EF4-FFF2-40B4-BE49-F238E27FC236}">
                <a16:creationId xmlns:a16="http://schemas.microsoft.com/office/drawing/2014/main" id="{327B1EB7-C77D-6BB3-D7BE-010CA4AA5D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02631738"/>
              </p:ext>
            </p:extLst>
          </p:nvPr>
        </p:nvGraphicFramePr>
        <p:xfrm>
          <a:off x="5600135" y="4723201"/>
          <a:ext cx="1884878" cy="51057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84878">
                  <a:extLst>
                    <a:ext uri="{9D8B030D-6E8A-4147-A177-3AD203B41FA5}">
                      <a16:colId xmlns:a16="http://schemas.microsoft.com/office/drawing/2014/main" val="2535621530"/>
                    </a:ext>
                  </a:extLst>
                </a:gridCol>
              </a:tblGrid>
              <a:tr h="255289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  <a:cs typeface="Calibri" panose="020F0502020204030204" pitchFamily="34" charset="0"/>
                        </a:rPr>
                        <a:t>Double variant</a:t>
                      </a:r>
                    </a:p>
                  </a:txBody>
                  <a:tcPr marL="4763" marR="4763" marT="4763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2513185"/>
                  </a:ext>
                </a:extLst>
              </a:tr>
              <a:tr h="255289">
                <a:tc>
                  <a:txBody>
                    <a:bodyPr/>
                    <a:lstStyle/>
                    <a:p>
                      <a:pPr algn="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游ゴシック" panose="020B0400000000000000" pitchFamily="50" charset="-128"/>
                        <a:cs typeface="Calibri" panose="020F0502020204030204" pitchFamily="34" charset="0"/>
                      </a:endParaRPr>
                    </a:p>
                  </a:txBody>
                  <a:tcPr marL="4763" marR="4763" marT="4763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5671373"/>
                  </a:ext>
                </a:extLst>
              </a:tr>
            </a:tbl>
          </a:graphicData>
        </a:graphic>
      </p:graphicFrame>
      <p:pic>
        <p:nvPicPr>
          <p:cNvPr id="31" name="図 30">
            <a:extLst>
              <a:ext uri="{FF2B5EF4-FFF2-40B4-BE49-F238E27FC236}">
                <a16:creationId xmlns:a16="http://schemas.microsoft.com/office/drawing/2014/main" id="{86712145-9D36-3154-0203-910BDFA3B91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747834" y="1390351"/>
            <a:ext cx="4036248" cy="2607488"/>
          </a:xfrm>
          <a:prstGeom prst="rect">
            <a:avLst/>
          </a:prstGeom>
        </p:spPr>
      </p:pic>
      <p:pic>
        <p:nvPicPr>
          <p:cNvPr id="37" name="図 36">
            <a:extLst>
              <a:ext uri="{FF2B5EF4-FFF2-40B4-BE49-F238E27FC236}">
                <a16:creationId xmlns:a16="http://schemas.microsoft.com/office/drawing/2014/main" id="{ACC24B6C-24EA-4ADB-013A-E7D451681C5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16079" y="1374236"/>
            <a:ext cx="4036248" cy="26074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16627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7</TotalTime>
  <Words>667</Words>
  <Application>Microsoft Office PowerPoint</Application>
  <PresentationFormat>Widescreen</PresentationFormat>
  <Paragraphs>281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游ゴシック</vt:lpstr>
      <vt:lpstr>游ゴシック Light</vt:lpstr>
      <vt:lpstr>Arial</vt:lpstr>
      <vt:lpstr>Calibri</vt:lpstr>
      <vt:lpstr>Times New Roman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akiHarada</dc:creator>
  <cp:lastModifiedBy>MDPI</cp:lastModifiedBy>
  <cp:revision>43</cp:revision>
  <dcterms:created xsi:type="dcterms:W3CDTF">2022-10-14T04:24:28Z</dcterms:created>
  <dcterms:modified xsi:type="dcterms:W3CDTF">2023-02-17T04:53:50Z</dcterms:modified>
</cp:coreProperties>
</file>